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56" d="100"/>
          <a:sy n="56" d="100"/>
        </p:scale>
        <p:origin x="489" y="3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Chart%20in%20Microsoft%20PowerPoint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559307443451292"/>
          <c:y val="6.6755267730317355E-2"/>
          <c:w val="0.6029163869230374"/>
          <c:h val="0.87374454949892055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[Chart in Microsoft PowerPoint]F3_454 &gt; 1%_genus_CTX'!$B$7</c:f>
              <c:strCache>
                <c:ptCount val="1"/>
                <c:pt idx="0">
                  <c:v>Bacteroides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[Chart in Microsoft PowerPoint]F3_454 &gt; 1%_genus_CTX'!$C$22:$H$22</c:f>
              <c:strCache>
                <c:ptCount val="6"/>
                <c:pt idx="0">
                  <c:v>CR_day 3</c:v>
                </c:pt>
                <c:pt idx="1">
                  <c:v>CR_day 4</c:v>
                </c:pt>
                <c:pt idx="2">
                  <c:v>CR_day 5</c:v>
                </c:pt>
                <c:pt idx="3">
                  <c:v>TR3_day 3</c:v>
                </c:pt>
                <c:pt idx="4">
                  <c:v>TR3_day 4</c:v>
                </c:pt>
                <c:pt idx="5">
                  <c:v>TR3_day 5</c:v>
                </c:pt>
              </c:strCache>
            </c:strRef>
          </c:cat>
          <c:val>
            <c:numRef>
              <c:f>'[Chart in Microsoft PowerPoint]F3_454 &gt; 1%_genus_CTX'!$C$7:$H$7</c:f>
              <c:numCache>
                <c:formatCode>General</c:formatCode>
                <c:ptCount val="6"/>
                <c:pt idx="0">
                  <c:v>73.88101983</c:v>
                </c:pt>
                <c:pt idx="1">
                  <c:v>74.353941773000003</c:v>
                </c:pt>
                <c:pt idx="2">
                  <c:v>78.661880546399999</c:v>
                </c:pt>
                <c:pt idx="3">
                  <c:v>77.81425891180001</c:v>
                </c:pt>
                <c:pt idx="4">
                  <c:v>74.733797817799996</c:v>
                </c:pt>
                <c:pt idx="5">
                  <c:v>81.1241425094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031-46FD-ABAC-D702A2838F07}"/>
            </c:ext>
          </c:extLst>
        </c:ser>
        <c:ser>
          <c:idx val="1"/>
          <c:order val="1"/>
          <c:tx>
            <c:strRef>
              <c:f>'[Chart in Microsoft PowerPoint]F3_454 &gt; 1%_genus_CTX'!$B$8</c:f>
              <c:strCache>
                <c:ptCount val="1"/>
                <c:pt idx="0">
                  <c:v>Parabacteroides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</c:spPr>
          <c:invertIfNegative val="0"/>
          <c:cat>
            <c:strRef>
              <c:f>'[Chart in Microsoft PowerPoint]F3_454 &gt; 1%_genus_CTX'!$C$22:$H$22</c:f>
              <c:strCache>
                <c:ptCount val="6"/>
                <c:pt idx="0">
                  <c:v>CR_day 3</c:v>
                </c:pt>
                <c:pt idx="1">
                  <c:v>CR_day 4</c:v>
                </c:pt>
                <c:pt idx="2">
                  <c:v>CR_day 5</c:v>
                </c:pt>
                <c:pt idx="3">
                  <c:v>TR3_day 3</c:v>
                </c:pt>
                <c:pt idx="4">
                  <c:v>TR3_day 4</c:v>
                </c:pt>
                <c:pt idx="5">
                  <c:v>TR3_day 5</c:v>
                </c:pt>
              </c:strCache>
            </c:strRef>
          </c:cat>
          <c:val>
            <c:numRef>
              <c:f>'[Chart in Microsoft PowerPoint]F3_454 &gt; 1%_genus_CTX'!$C$8:$H$8</c:f>
              <c:numCache>
                <c:formatCode>General</c:formatCode>
                <c:ptCount val="6"/>
                <c:pt idx="0">
                  <c:v>1.3597733711</c:v>
                </c:pt>
                <c:pt idx="1">
                  <c:v>0.99225820521200003</c:v>
                </c:pt>
                <c:pt idx="2">
                  <c:v>0.52846744441100002</c:v>
                </c:pt>
                <c:pt idx="3">
                  <c:v>1.1843339587199999</c:v>
                </c:pt>
                <c:pt idx="4">
                  <c:v>0.9859340081500001</c:v>
                </c:pt>
                <c:pt idx="5">
                  <c:v>0.752378844877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031-46FD-ABAC-D702A2838F07}"/>
            </c:ext>
          </c:extLst>
        </c:ser>
        <c:ser>
          <c:idx val="2"/>
          <c:order val="2"/>
          <c:tx>
            <c:strRef>
              <c:f>'[Chart in Microsoft PowerPoint]F3_454 &gt; 1%_genus_CTX'!$B$9</c:f>
              <c:strCache>
                <c:ptCount val="1"/>
                <c:pt idx="0">
                  <c:v>Anaerococcus</c:v>
                </c:pt>
              </c:strCache>
            </c:strRef>
          </c:tx>
          <c:spPr>
            <a:solidFill>
              <a:srgbClr val="00B050"/>
            </a:solidFill>
          </c:spPr>
          <c:invertIfNegative val="0"/>
          <c:cat>
            <c:strRef>
              <c:f>'[Chart in Microsoft PowerPoint]F3_454 &gt; 1%_genus_CTX'!$C$22:$H$22</c:f>
              <c:strCache>
                <c:ptCount val="6"/>
                <c:pt idx="0">
                  <c:v>CR_day 3</c:v>
                </c:pt>
                <c:pt idx="1">
                  <c:v>CR_day 4</c:v>
                </c:pt>
                <c:pt idx="2">
                  <c:v>CR_day 5</c:v>
                </c:pt>
                <c:pt idx="3">
                  <c:v>TR3_day 3</c:v>
                </c:pt>
                <c:pt idx="4">
                  <c:v>TR3_day 4</c:v>
                </c:pt>
                <c:pt idx="5">
                  <c:v>TR3_day 5</c:v>
                </c:pt>
              </c:strCache>
            </c:strRef>
          </c:cat>
          <c:val>
            <c:numRef>
              <c:f>'[Chart in Microsoft PowerPoint]F3_454 &gt; 1%_genus_CTX'!$C$9:$H$9</c:f>
              <c:numCache>
                <c:formatCode>General</c:formatCode>
                <c:ptCount val="6"/>
                <c:pt idx="0">
                  <c:v>1.45042492918</c:v>
                </c:pt>
                <c:pt idx="1">
                  <c:v>1.5156471486200001</c:v>
                </c:pt>
                <c:pt idx="2">
                  <c:v>1.1765878950999999</c:v>
                </c:pt>
                <c:pt idx="3">
                  <c:v>0.44559099437100003</c:v>
                </c:pt>
                <c:pt idx="4">
                  <c:v>1.1831208097800001</c:v>
                </c:pt>
                <c:pt idx="5">
                  <c:v>1.250276609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031-46FD-ABAC-D702A2838F07}"/>
            </c:ext>
          </c:extLst>
        </c:ser>
        <c:ser>
          <c:idx val="3"/>
          <c:order val="3"/>
          <c:tx>
            <c:strRef>
              <c:f>'[Chart in Microsoft PowerPoint]F3_454 &gt; 1%_genus_CTX'!$B$10</c:f>
              <c:strCache>
                <c:ptCount val="1"/>
                <c:pt idx="0">
                  <c:v>Peptoniphilus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</c:spPr>
          <c:invertIfNegative val="0"/>
          <c:cat>
            <c:strRef>
              <c:f>'[Chart in Microsoft PowerPoint]F3_454 &gt; 1%_genus_CTX'!$C$22:$H$22</c:f>
              <c:strCache>
                <c:ptCount val="6"/>
                <c:pt idx="0">
                  <c:v>CR_day 3</c:v>
                </c:pt>
                <c:pt idx="1">
                  <c:v>CR_day 4</c:v>
                </c:pt>
                <c:pt idx="2">
                  <c:v>CR_day 5</c:v>
                </c:pt>
                <c:pt idx="3">
                  <c:v>TR3_day 3</c:v>
                </c:pt>
                <c:pt idx="4">
                  <c:v>TR3_day 4</c:v>
                </c:pt>
                <c:pt idx="5">
                  <c:v>TR3_day 5</c:v>
                </c:pt>
              </c:strCache>
            </c:strRef>
          </c:cat>
          <c:val>
            <c:numRef>
              <c:f>'[Chart in Microsoft PowerPoint]F3_454 &gt; 1%_genus_CTX'!$C$10:$H$10</c:f>
              <c:numCache>
                <c:formatCode>General</c:formatCode>
                <c:ptCount val="6"/>
                <c:pt idx="0">
                  <c:v>2.9121813031200001</c:v>
                </c:pt>
                <c:pt idx="1">
                  <c:v>3.4020281321600003</c:v>
                </c:pt>
                <c:pt idx="2">
                  <c:v>4.0981154651500002</c:v>
                </c:pt>
                <c:pt idx="3">
                  <c:v>3.34193245779</c:v>
                </c:pt>
                <c:pt idx="4">
                  <c:v>5.7315630340500006</c:v>
                </c:pt>
                <c:pt idx="5">
                  <c:v>4.304049568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031-46FD-ABAC-D702A2838F07}"/>
            </c:ext>
          </c:extLst>
        </c:ser>
        <c:ser>
          <c:idx val="4"/>
          <c:order val="4"/>
          <c:tx>
            <c:strRef>
              <c:f>'[Chart in Microsoft PowerPoint]F3_454 &gt; 1%_genus_CTX'!$B$11</c:f>
              <c:strCache>
                <c:ptCount val="1"/>
                <c:pt idx="0">
                  <c:v>uc Lachnospiraceae</c:v>
                </c:pt>
              </c:strCache>
            </c:strRef>
          </c:tx>
          <c:spPr>
            <a:solidFill>
              <a:schemeClr val="accent3">
                <a:lumMod val="75000"/>
              </a:schemeClr>
            </a:solidFill>
          </c:spPr>
          <c:invertIfNegative val="0"/>
          <c:cat>
            <c:strRef>
              <c:f>'[Chart in Microsoft PowerPoint]F3_454 &gt; 1%_genus_CTX'!$C$22:$H$22</c:f>
              <c:strCache>
                <c:ptCount val="6"/>
                <c:pt idx="0">
                  <c:v>CR_day 3</c:v>
                </c:pt>
                <c:pt idx="1">
                  <c:v>CR_day 4</c:v>
                </c:pt>
                <c:pt idx="2">
                  <c:v>CR_day 5</c:v>
                </c:pt>
                <c:pt idx="3">
                  <c:v>TR3_day 3</c:v>
                </c:pt>
                <c:pt idx="4">
                  <c:v>TR3_day 4</c:v>
                </c:pt>
                <c:pt idx="5">
                  <c:v>TR3_day 5</c:v>
                </c:pt>
              </c:strCache>
            </c:strRef>
          </c:cat>
          <c:val>
            <c:numRef>
              <c:f>'[Chart in Microsoft PowerPoint]F3_454 &gt; 1%_genus_CTX'!$C$11:$H$11</c:f>
              <c:numCache>
                <c:formatCode>General</c:formatCode>
                <c:ptCount val="6"/>
                <c:pt idx="0">
                  <c:v>5.3144475920699996</c:v>
                </c:pt>
                <c:pt idx="1">
                  <c:v>6.1825318940100003</c:v>
                </c:pt>
                <c:pt idx="2">
                  <c:v>4.1778841359999994</c:v>
                </c:pt>
                <c:pt idx="3">
                  <c:v>4.32692307692</c:v>
                </c:pt>
                <c:pt idx="4">
                  <c:v>6.2048113579599997</c:v>
                </c:pt>
                <c:pt idx="5">
                  <c:v>4.3483071475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031-46FD-ABAC-D702A2838F07}"/>
            </c:ext>
          </c:extLst>
        </c:ser>
        <c:ser>
          <c:idx val="5"/>
          <c:order val="5"/>
          <c:tx>
            <c:strRef>
              <c:f>'[Chart in Microsoft PowerPoint]F3_454 &gt; 1%_genus_CTX'!$B$12</c:f>
              <c:strCache>
                <c:ptCount val="1"/>
                <c:pt idx="0">
                  <c:v>Coprococcus</c:v>
                </c:pt>
              </c:strCache>
            </c:strRef>
          </c:tx>
          <c:spPr>
            <a:solidFill>
              <a:srgbClr val="92D050"/>
            </a:solidFill>
          </c:spPr>
          <c:invertIfNegative val="0"/>
          <c:cat>
            <c:strRef>
              <c:f>'[Chart in Microsoft PowerPoint]F3_454 &gt; 1%_genus_CTX'!$C$22:$H$22</c:f>
              <c:strCache>
                <c:ptCount val="6"/>
                <c:pt idx="0">
                  <c:v>CR_day 3</c:v>
                </c:pt>
                <c:pt idx="1">
                  <c:v>CR_day 4</c:v>
                </c:pt>
                <c:pt idx="2">
                  <c:v>CR_day 5</c:v>
                </c:pt>
                <c:pt idx="3">
                  <c:v>TR3_day 3</c:v>
                </c:pt>
                <c:pt idx="4">
                  <c:v>TR3_day 4</c:v>
                </c:pt>
                <c:pt idx="5">
                  <c:v>TR3_day 5</c:v>
                </c:pt>
              </c:strCache>
            </c:strRef>
          </c:cat>
          <c:val>
            <c:numRef>
              <c:f>'[Chart in Microsoft PowerPoint]F3_454 &gt; 1%_genus_CTX'!$C$12:$H$12</c:f>
              <c:numCache>
                <c:formatCode>General</c:formatCode>
                <c:ptCount val="6"/>
                <c:pt idx="0">
                  <c:v>0.26062322946200001</c:v>
                </c:pt>
                <c:pt idx="1">
                  <c:v>0.29440628066699998</c:v>
                </c:pt>
                <c:pt idx="2">
                  <c:v>0.25924818027699997</c:v>
                </c:pt>
                <c:pt idx="3">
                  <c:v>2.3921200750499998</c:v>
                </c:pt>
                <c:pt idx="4">
                  <c:v>0.53897725778899996</c:v>
                </c:pt>
                <c:pt idx="5">
                  <c:v>0.199159105996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7031-46FD-ABAC-D702A2838F07}"/>
            </c:ext>
          </c:extLst>
        </c:ser>
        <c:ser>
          <c:idx val="7"/>
          <c:order val="6"/>
          <c:tx>
            <c:strRef>
              <c:f>'[Chart in Microsoft PowerPoint]F3_454 &gt; 1%_genus_CTX'!$B$14</c:f>
              <c:strCache>
                <c:ptCount val="1"/>
                <c:pt idx="0">
                  <c:v>Lachnospiraceae Incertae Sedis</c:v>
                </c:pt>
              </c:strCache>
            </c:strRef>
          </c:tx>
          <c:spPr>
            <a:solidFill>
              <a:schemeClr val="accent3">
                <a:lumMod val="40000"/>
                <a:lumOff val="60000"/>
              </a:schemeClr>
            </a:solidFill>
          </c:spPr>
          <c:invertIfNegative val="0"/>
          <c:cat>
            <c:strRef>
              <c:f>'[Chart in Microsoft PowerPoint]F3_454 &gt; 1%_genus_CTX'!$C$22:$H$22</c:f>
              <c:strCache>
                <c:ptCount val="6"/>
                <c:pt idx="0">
                  <c:v>CR_day 3</c:v>
                </c:pt>
                <c:pt idx="1">
                  <c:v>CR_day 4</c:v>
                </c:pt>
                <c:pt idx="2">
                  <c:v>CR_day 5</c:v>
                </c:pt>
                <c:pt idx="3">
                  <c:v>TR3_day 3</c:v>
                </c:pt>
                <c:pt idx="4">
                  <c:v>TR3_day 4</c:v>
                </c:pt>
                <c:pt idx="5">
                  <c:v>TR3_day 5</c:v>
                </c:pt>
              </c:strCache>
            </c:strRef>
          </c:cat>
          <c:val>
            <c:numRef>
              <c:f>'[Chart in Microsoft PowerPoint]F3_454 &gt; 1%_genus_CTX'!$C$14:$H$14</c:f>
              <c:numCache>
                <c:formatCode>General</c:formatCode>
                <c:ptCount val="6"/>
                <c:pt idx="0">
                  <c:v>3.9093484419300002</c:v>
                </c:pt>
                <c:pt idx="1">
                  <c:v>5.01581070767</c:v>
                </c:pt>
                <c:pt idx="2">
                  <c:v>3.0112673247599999</c:v>
                </c:pt>
                <c:pt idx="3">
                  <c:v>4.3621013133200002</c:v>
                </c:pt>
                <c:pt idx="4">
                  <c:v>3.7071118706499999</c:v>
                </c:pt>
                <c:pt idx="5">
                  <c:v>2.12436379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7031-46FD-ABAC-D702A2838F07}"/>
            </c:ext>
          </c:extLst>
        </c:ser>
        <c:ser>
          <c:idx val="10"/>
          <c:order val="7"/>
          <c:tx>
            <c:strRef>
              <c:f>'[Chart in Microsoft PowerPoint]F3_454 &gt; 1%_genus_CTX'!$B$17</c:f>
              <c:strCache>
                <c:ptCount val="1"/>
                <c:pt idx="0">
                  <c:v>uc Ruminococcaceae</c:v>
                </c:pt>
              </c:strCache>
            </c:strRef>
          </c:tx>
          <c:spPr>
            <a:solidFill>
              <a:srgbClr val="66FFCC"/>
            </a:solidFill>
          </c:spPr>
          <c:invertIfNegative val="0"/>
          <c:cat>
            <c:strRef>
              <c:f>'[Chart in Microsoft PowerPoint]F3_454 &gt; 1%_genus_CTX'!$C$22:$H$22</c:f>
              <c:strCache>
                <c:ptCount val="6"/>
                <c:pt idx="0">
                  <c:v>CR_day 3</c:v>
                </c:pt>
                <c:pt idx="1">
                  <c:v>CR_day 4</c:v>
                </c:pt>
                <c:pt idx="2">
                  <c:v>CR_day 5</c:v>
                </c:pt>
                <c:pt idx="3">
                  <c:v>TR3_day 3</c:v>
                </c:pt>
                <c:pt idx="4">
                  <c:v>TR3_day 4</c:v>
                </c:pt>
                <c:pt idx="5">
                  <c:v>TR3_day 5</c:v>
                </c:pt>
              </c:strCache>
            </c:strRef>
          </c:cat>
          <c:val>
            <c:numRef>
              <c:f>'[Chart in Microsoft PowerPoint]F3_454 &gt; 1%_genus_CTX'!$C$17:$H$17</c:f>
              <c:numCache>
                <c:formatCode>General</c:formatCode>
                <c:ptCount val="6"/>
                <c:pt idx="0">
                  <c:v>6.2096317280500006</c:v>
                </c:pt>
                <c:pt idx="1">
                  <c:v>4.9503870897400004</c:v>
                </c:pt>
                <c:pt idx="2">
                  <c:v>2.9215275700499999</c:v>
                </c:pt>
                <c:pt idx="3">
                  <c:v>0.99671669793600004</c:v>
                </c:pt>
                <c:pt idx="4">
                  <c:v>1.9850138030800002</c:v>
                </c:pt>
                <c:pt idx="5">
                  <c:v>2.36778048241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7031-46FD-ABAC-D702A2838F07}"/>
            </c:ext>
          </c:extLst>
        </c:ser>
        <c:ser>
          <c:idx val="11"/>
          <c:order val="8"/>
          <c:tx>
            <c:strRef>
              <c:f>'[Chart in Microsoft PowerPoint]F3_454 &gt; 1%_genus_CTX'!$B$18</c:f>
              <c:strCache>
                <c:ptCount val="1"/>
                <c:pt idx="0">
                  <c:v>Others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cat>
            <c:strRef>
              <c:f>'[Chart in Microsoft PowerPoint]F3_454 &gt; 1%_genus_CTX'!$C$22:$H$22</c:f>
              <c:strCache>
                <c:ptCount val="6"/>
                <c:pt idx="0">
                  <c:v>CR_day 3</c:v>
                </c:pt>
                <c:pt idx="1">
                  <c:v>CR_day 4</c:v>
                </c:pt>
                <c:pt idx="2">
                  <c:v>CR_day 5</c:v>
                </c:pt>
                <c:pt idx="3">
                  <c:v>TR3_day 3</c:v>
                </c:pt>
                <c:pt idx="4">
                  <c:v>TR3_day 4</c:v>
                </c:pt>
                <c:pt idx="5">
                  <c:v>TR3_day 5</c:v>
                </c:pt>
              </c:strCache>
            </c:strRef>
          </c:cat>
          <c:val>
            <c:numRef>
              <c:f>'[Chart in Microsoft PowerPoint]F3_454 &gt; 1%_genus_CTX'!$C$18:$H$18</c:f>
              <c:numCache>
                <c:formatCode>General</c:formatCode>
                <c:ptCount val="6"/>
                <c:pt idx="0">
                  <c:v>4.6345609065327835</c:v>
                </c:pt>
                <c:pt idx="1">
                  <c:v>2.9658706792909868</c:v>
                </c:pt>
                <c:pt idx="2">
                  <c:v>2.8617010669315874</c:v>
                </c:pt>
                <c:pt idx="3">
                  <c:v>5.0891181988960028</c:v>
                </c:pt>
                <c:pt idx="4">
                  <c:v>4.863941106864317</c:v>
                </c:pt>
                <c:pt idx="5">
                  <c:v>3.50741314450078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031-46FD-ABAC-D702A2838F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overlap val="100"/>
        <c:axId val="136335744"/>
        <c:axId val="136337280"/>
      </c:barChart>
      <c:catAx>
        <c:axId val="1363357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ln>
            <a:solidFill>
              <a:schemeClr val="tx1"/>
            </a:solidFill>
          </a:ln>
        </c:spPr>
        <c:crossAx val="136337280"/>
        <c:crosses val="autoZero"/>
        <c:auto val="1"/>
        <c:lblAlgn val="ctr"/>
        <c:lblOffset val="100"/>
        <c:noMultiLvlLbl val="0"/>
      </c:catAx>
      <c:valAx>
        <c:axId val="13633728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Relative abundance</a:t>
                </a:r>
              </a:p>
            </c:rich>
          </c:tx>
          <c:layout>
            <c:manualLayout>
              <c:xMode val="edge"/>
              <c:yMode val="edge"/>
              <c:x val="8.0904471766627527E-3"/>
              <c:y val="0.34104624532552902"/>
            </c:manualLayout>
          </c:layout>
          <c:overlay val="0"/>
        </c:title>
        <c:numFmt formatCode="0%" sourceLinked="1"/>
        <c:majorTickMark val="out"/>
        <c:minorTickMark val="none"/>
        <c:tickLblPos val="nextTo"/>
        <c:crossAx val="136335744"/>
        <c:crosses val="autoZero"/>
        <c:crossBetween val="between"/>
      </c:valAx>
      <c:spPr>
        <a:ln>
          <a:noFill/>
        </a:ln>
      </c:spPr>
    </c:plotArea>
    <c:legend>
      <c:legendPos val="r"/>
      <c:legendEntry>
        <c:idx val="1"/>
        <c:txPr>
          <a:bodyPr/>
          <a:lstStyle/>
          <a:p>
            <a:pPr>
              <a:defRPr i="1"/>
            </a:pPr>
            <a:endParaRPr lang="de-DE"/>
          </a:p>
        </c:txPr>
      </c:legendEntry>
      <c:legendEntry>
        <c:idx val="2"/>
        <c:txPr>
          <a:bodyPr/>
          <a:lstStyle/>
          <a:p>
            <a:pPr>
              <a:defRPr i="1"/>
            </a:pPr>
            <a:endParaRPr lang="de-DE"/>
          </a:p>
        </c:txPr>
      </c:legendEntry>
      <c:legendEntry>
        <c:idx val="3"/>
        <c:txPr>
          <a:bodyPr/>
          <a:lstStyle/>
          <a:p>
            <a:pPr>
              <a:defRPr i="1"/>
            </a:pPr>
            <a:endParaRPr lang="de-DE"/>
          </a:p>
        </c:txPr>
      </c:legendEntry>
      <c:legendEntry>
        <c:idx val="4"/>
        <c:txPr>
          <a:bodyPr/>
          <a:lstStyle/>
          <a:p>
            <a:pPr>
              <a:defRPr i="1"/>
            </a:pPr>
            <a:endParaRPr lang="de-DE"/>
          </a:p>
        </c:txPr>
      </c:legendEntry>
      <c:legendEntry>
        <c:idx val="5"/>
        <c:txPr>
          <a:bodyPr/>
          <a:lstStyle/>
          <a:p>
            <a:pPr>
              <a:defRPr i="1"/>
            </a:pPr>
            <a:endParaRPr lang="de-DE"/>
          </a:p>
        </c:txPr>
      </c:legendEntry>
      <c:legendEntry>
        <c:idx val="6"/>
        <c:txPr>
          <a:bodyPr/>
          <a:lstStyle/>
          <a:p>
            <a:pPr>
              <a:defRPr i="1"/>
            </a:pPr>
            <a:endParaRPr lang="de-DE"/>
          </a:p>
        </c:txPr>
      </c:legendEntry>
      <c:legendEntry>
        <c:idx val="7"/>
        <c:txPr>
          <a:bodyPr/>
          <a:lstStyle/>
          <a:p>
            <a:pPr>
              <a:defRPr i="1"/>
            </a:pPr>
            <a:endParaRPr lang="de-DE"/>
          </a:p>
        </c:txPr>
      </c:legendEntry>
      <c:legendEntry>
        <c:idx val="8"/>
        <c:txPr>
          <a:bodyPr/>
          <a:lstStyle/>
          <a:p>
            <a:pPr>
              <a:defRPr i="1"/>
            </a:pPr>
            <a:endParaRPr lang="de-DE"/>
          </a:p>
        </c:txPr>
      </c:legendEntry>
      <c:layout>
        <c:manualLayout>
          <c:xMode val="edge"/>
          <c:yMode val="edge"/>
          <c:x val="0.73669816272965882"/>
          <c:y val="5.8405688600164145E-2"/>
          <c:w val="0.24849229002624673"/>
          <c:h val="0.66151014630715177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1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D3829-1452-49A8-8486-4802A43EF8CD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C80B5-E8E0-4A91-8E24-6D5831C97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6617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D3829-1452-49A8-8486-4802A43EF8CD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C80B5-E8E0-4A91-8E24-6D5831C97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7922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D3829-1452-49A8-8486-4802A43EF8CD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C80B5-E8E0-4A91-8E24-6D5831C97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678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D3829-1452-49A8-8486-4802A43EF8CD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C80B5-E8E0-4A91-8E24-6D5831C97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6417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D3829-1452-49A8-8486-4802A43EF8CD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C80B5-E8E0-4A91-8E24-6D5831C97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1039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D3829-1452-49A8-8486-4802A43EF8CD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C80B5-E8E0-4A91-8E24-6D5831C97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573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D3829-1452-49A8-8486-4802A43EF8CD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C80B5-E8E0-4A91-8E24-6D5831C97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379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D3829-1452-49A8-8486-4802A43EF8CD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C80B5-E8E0-4A91-8E24-6D5831C97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9799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D3829-1452-49A8-8486-4802A43EF8CD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C80B5-E8E0-4A91-8E24-6D5831C97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379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D3829-1452-49A8-8486-4802A43EF8CD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C80B5-E8E0-4A91-8E24-6D5831C97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0167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D3829-1452-49A8-8486-4802A43EF8CD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C80B5-E8E0-4A91-8E24-6D5831C97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0506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3D3829-1452-49A8-8486-4802A43EF8CD}" type="datetimeFigureOut">
              <a:rPr lang="en-US" smtClean="0"/>
              <a:t>10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BC80B5-E8E0-4A91-8E24-6D5831C971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416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0744965"/>
              </p:ext>
            </p:extLst>
          </p:nvPr>
        </p:nvGraphicFramePr>
        <p:xfrm>
          <a:off x="1447800" y="522909"/>
          <a:ext cx="6096000" cy="56327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0" name="Group 9"/>
          <p:cNvGrpSpPr/>
          <p:nvPr/>
        </p:nvGrpSpPr>
        <p:grpSpPr>
          <a:xfrm>
            <a:off x="1939280" y="237044"/>
            <a:ext cx="4272122" cy="5588331"/>
            <a:chOff x="1939280" y="248589"/>
            <a:chExt cx="4272122" cy="5588331"/>
          </a:xfrm>
        </p:grpSpPr>
        <p:sp>
          <p:nvSpPr>
            <p:cNvPr id="5" name="TextBox 2"/>
            <p:cNvSpPr txBox="1"/>
            <p:nvPr/>
          </p:nvSpPr>
          <p:spPr>
            <a:xfrm>
              <a:off x="2209799" y="586740"/>
              <a:ext cx="1865541" cy="27432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R</a:t>
              </a:r>
            </a:p>
          </p:txBody>
        </p:sp>
        <p:cxnSp>
          <p:nvCxnSpPr>
            <p:cNvPr id="6" name="Straight Connector 5"/>
            <p:cNvCxnSpPr/>
            <p:nvPr/>
          </p:nvCxnSpPr>
          <p:spPr>
            <a:xfrm>
              <a:off x="2209800" y="511528"/>
              <a:ext cx="36576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TextBox 2"/>
            <p:cNvSpPr txBox="1"/>
            <p:nvPr/>
          </p:nvSpPr>
          <p:spPr>
            <a:xfrm>
              <a:off x="4088120" y="586740"/>
              <a:ext cx="1703080" cy="27432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R3</a:t>
              </a:r>
            </a:p>
          </p:txBody>
        </p:sp>
        <p:sp>
          <p:nvSpPr>
            <p:cNvPr id="8" name="TextBox 2"/>
            <p:cNvSpPr txBox="1"/>
            <p:nvPr/>
          </p:nvSpPr>
          <p:spPr>
            <a:xfrm>
              <a:off x="1939280" y="248589"/>
              <a:ext cx="4272122" cy="27432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 last days of period B (CRO II)</a:t>
              </a:r>
            </a:p>
          </p:txBody>
        </p:sp>
        <p:cxnSp>
          <p:nvCxnSpPr>
            <p:cNvPr id="9" name="Straight Connector 8"/>
            <p:cNvCxnSpPr/>
            <p:nvPr/>
          </p:nvCxnSpPr>
          <p:spPr>
            <a:xfrm>
              <a:off x="4038600" y="533400"/>
              <a:ext cx="0" cy="5303520"/>
            </a:xfrm>
            <a:prstGeom prst="line">
              <a:avLst/>
            </a:prstGeom>
            <a:ln w="15875">
              <a:solidFill>
                <a:schemeClr val="bg1">
                  <a:lumMod val="5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0820863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ISG D-AgrL - ETH Züri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hlbaum  Sophie</dc:creator>
  <cp:lastModifiedBy>Sophie Fehlbaum</cp:lastModifiedBy>
  <cp:revision>11</cp:revision>
  <dcterms:created xsi:type="dcterms:W3CDTF">2014-12-30T16:07:31Z</dcterms:created>
  <dcterms:modified xsi:type="dcterms:W3CDTF">2016-10-21T07:30:12Z</dcterms:modified>
</cp:coreProperties>
</file>